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3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92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hwsedero" initials="h" lastIdx="2" clrIdx="0"/>
  <p:cmAuthor id="1" name="Soundarya Srirangan" initials="SS" lastIdx="9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CEC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43" autoAdjust="0"/>
    <p:restoredTop sz="99856" autoAdjust="0"/>
  </p:normalViewPr>
  <p:slideViewPr>
    <p:cSldViewPr>
      <p:cViewPr>
        <p:scale>
          <a:sx n="76" d="100"/>
          <a:sy n="76" d="100"/>
        </p:scale>
        <p:origin x="1456" y="-612"/>
      </p:cViewPr>
      <p:guideLst>
        <p:guide orient="horz" pos="3792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53" d="100"/>
          <a:sy n="53" d="100"/>
        </p:scale>
        <p:origin x="2624" y="28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956205707995148"/>
          <c:y val="0.21823753280839903"/>
          <c:w val="0.84923484278488393"/>
          <c:h val="0.66110367454068275"/>
        </c:manualLayout>
      </c:layout>
      <c:scatterChart>
        <c:scatterStyle val="lineMarker"/>
        <c:varyColors val="0"/>
        <c:ser>
          <c:idx val="0"/>
          <c:order val="0"/>
          <c:tx>
            <c:strRef>
              <c:f>'Cell counts_first time'!$G$3</c:f>
              <c:strCache>
                <c:ptCount val="1"/>
                <c:pt idx="0">
                  <c:v>LD 25°C</c:v>
                </c:pt>
              </c:strCache>
            </c:strRef>
          </c:tx>
          <c:spPr>
            <a:ln w="31750">
              <a:solidFill>
                <a:schemeClr val="tx2">
                  <a:lumMod val="60000"/>
                  <a:lumOff val="40000"/>
                </a:schemeClr>
              </a:solidFill>
              <a:prstDash val="sysDash"/>
            </a:ln>
          </c:spPr>
          <c:marker>
            <c:symbol val="diamond"/>
            <c:size val="9"/>
            <c:spPr>
              <a:solidFill>
                <a:schemeClr val="tx2">
                  <a:lumMod val="60000"/>
                  <a:lumOff val="40000"/>
                </a:schemeClr>
              </a:solidFill>
              <a:ln>
                <a:solidFill>
                  <a:schemeClr val="tx2">
                    <a:lumMod val="60000"/>
                    <a:lumOff val="4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ell counts_first time'!$T$3:$AC$3</c:f>
                <c:numCache>
                  <c:formatCode>General</c:formatCode>
                  <c:ptCount val="10"/>
                  <c:pt idx="0">
                    <c:v>19279.198634798075</c:v>
                  </c:pt>
                  <c:pt idx="1">
                    <c:v>87956.665466580802</c:v>
                  </c:pt>
                  <c:pt idx="2">
                    <c:v>42438.190347845884</c:v>
                  </c:pt>
                  <c:pt idx="3">
                    <c:v>66322.497021079325</c:v>
                  </c:pt>
                  <c:pt idx="4">
                    <c:v>43252.970354003861</c:v>
                  </c:pt>
                  <c:pt idx="5">
                    <c:v>39028.390663436687</c:v>
                  </c:pt>
                  <c:pt idx="6">
                    <c:v>87777.338254876944</c:v>
                  </c:pt>
                  <c:pt idx="7">
                    <c:v>146382.30008364335</c:v>
                  </c:pt>
                  <c:pt idx="8">
                    <c:v>150300.6246752732</c:v>
                  </c:pt>
                  <c:pt idx="9">
                    <c:v>145021.55012273171</c:v>
                  </c:pt>
                </c:numCache>
              </c:numRef>
            </c:plus>
            <c:minus>
              <c:numRef>
                <c:f>'Cell counts_first time'!$T$3:$AC$3</c:f>
                <c:numCache>
                  <c:formatCode>General</c:formatCode>
                  <c:ptCount val="10"/>
                  <c:pt idx="0">
                    <c:v>19279.198634798075</c:v>
                  </c:pt>
                  <c:pt idx="1">
                    <c:v>87956.665466580802</c:v>
                  </c:pt>
                  <c:pt idx="2">
                    <c:v>42438.190347845884</c:v>
                  </c:pt>
                  <c:pt idx="3">
                    <c:v>66322.497021079325</c:v>
                  </c:pt>
                  <c:pt idx="4">
                    <c:v>43252.970354003861</c:v>
                  </c:pt>
                  <c:pt idx="5">
                    <c:v>39028.390663436687</c:v>
                  </c:pt>
                  <c:pt idx="6">
                    <c:v>87777.338254876944</c:v>
                  </c:pt>
                  <c:pt idx="7">
                    <c:v>146382.30008364335</c:v>
                  </c:pt>
                  <c:pt idx="8">
                    <c:v>150300.6246752732</c:v>
                  </c:pt>
                  <c:pt idx="9">
                    <c:v>145021.55012273171</c:v>
                  </c:pt>
                </c:numCache>
              </c:numRef>
            </c:minus>
          </c:errBars>
          <c:xVal>
            <c:numRef>
              <c:f>'Cell counts_first time'!$H$2:$Q$2</c:f>
              <c:numCache>
                <c:formatCode>General</c:formatCode>
                <c:ptCount val="10"/>
                <c:pt idx="0">
                  <c:v>0</c:v>
                </c:pt>
                <c:pt idx="1">
                  <c:v>6</c:v>
                </c:pt>
                <c:pt idx="2">
                  <c:v>16</c:v>
                </c:pt>
                <c:pt idx="3">
                  <c:v>23</c:v>
                </c:pt>
                <c:pt idx="4">
                  <c:v>25</c:v>
                </c:pt>
                <c:pt idx="5">
                  <c:v>30</c:v>
                </c:pt>
                <c:pt idx="6">
                  <c:v>40</c:v>
                </c:pt>
                <c:pt idx="7">
                  <c:v>47</c:v>
                </c:pt>
                <c:pt idx="8">
                  <c:v>49</c:v>
                </c:pt>
                <c:pt idx="9">
                  <c:v>54</c:v>
                </c:pt>
              </c:numCache>
            </c:numRef>
          </c:xVal>
          <c:yVal>
            <c:numRef>
              <c:f>'Cell counts_first time'!$H$3:$Q$3</c:f>
              <c:numCache>
                <c:formatCode>General</c:formatCode>
                <c:ptCount val="10"/>
                <c:pt idx="0">
                  <c:v>520666.66666666669</c:v>
                </c:pt>
                <c:pt idx="1">
                  <c:v>567666.66666666686</c:v>
                </c:pt>
                <c:pt idx="2">
                  <c:v>591833.33333333372</c:v>
                </c:pt>
                <c:pt idx="3">
                  <c:v>1011111.1111111111</c:v>
                </c:pt>
                <c:pt idx="4">
                  <c:v>1052277.7777777778</c:v>
                </c:pt>
                <c:pt idx="5">
                  <c:v>899055.5555555555</c:v>
                </c:pt>
                <c:pt idx="6">
                  <c:v>1216111.111111111</c:v>
                </c:pt>
                <c:pt idx="7">
                  <c:v>1859444.4444444445</c:v>
                </c:pt>
                <c:pt idx="8">
                  <c:v>1985555.555555555</c:v>
                </c:pt>
                <c:pt idx="9">
                  <c:v>1816666.666666667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Cell counts_first time'!$G$4</c:f>
              <c:strCache>
                <c:ptCount val="1"/>
                <c:pt idx="0">
                  <c:v>LL 25°C</c:v>
                </c:pt>
              </c:strCache>
            </c:strRef>
          </c:tx>
          <c:spPr>
            <a:ln w="31750">
              <a:solidFill>
                <a:schemeClr val="tx2">
                  <a:lumMod val="60000"/>
                  <a:lumOff val="40000"/>
                </a:schemeClr>
              </a:solidFill>
            </a:ln>
          </c:spPr>
          <c:marker>
            <c:spPr>
              <a:solidFill>
                <a:schemeClr val="tx2">
                  <a:lumMod val="60000"/>
                  <a:lumOff val="40000"/>
                </a:schemeClr>
              </a:solidFill>
              <a:ln>
                <a:solidFill>
                  <a:schemeClr val="tx2">
                    <a:lumMod val="60000"/>
                    <a:lumOff val="4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ell counts_first time'!$T$4:$AC$4</c:f>
                <c:numCache>
                  <c:formatCode>General</c:formatCode>
                  <c:ptCount val="10"/>
                  <c:pt idx="0">
                    <c:v>19279.198634798075</c:v>
                  </c:pt>
                  <c:pt idx="1">
                    <c:v>34356.585977072878</c:v>
                  </c:pt>
                  <c:pt idx="2">
                    <c:v>58513.353176860408</c:v>
                  </c:pt>
                  <c:pt idx="3">
                    <c:v>70848.625800207534</c:v>
                  </c:pt>
                  <c:pt idx="4">
                    <c:v>69540.006471095447</c:v>
                  </c:pt>
                  <c:pt idx="5">
                    <c:v>50314.013952377143</c:v>
                  </c:pt>
                  <c:pt idx="6">
                    <c:v>98724.504444326449</c:v>
                  </c:pt>
                  <c:pt idx="7">
                    <c:v>166027.94276198614</c:v>
                  </c:pt>
                  <c:pt idx="8">
                    <c:v>101922.49233826814</c:v>
                  </c:pt>
                  <c:pt idx="9">
                    <c:v>149122.43292006751</c:v>
                  </c:pt>
                </c:numCache>
              </c:numRef>
            </c:plus>
            <c:minus>
              <c:numRef>
                <c:f>'Cell counts_first time'!$T$4:$AC$4</c:f>
                <c:numCache>
                  <c:formatCode>General</c:formatCode>
                  <c:ptCount val="10"/>
                  <c:pt idx="0">
                    <c:v>19279.198634798075</c:v>
                  </c:pt>
                  <c:pt idx="1">
                    <c:v>34356.585977072878</c:v>
                  </c:pt>
                  <c:pt idx="2">
                    <c:v>58513.353176860408</c:v>
                  </c:pt>
                  <c:pt idx="3">
                    <c:v>70848.625800207534</c:v>
                  </c:pt>
                  <c:pt idx="4">
                    <c:v>69540.006471095447</c:v>
                  </c:pt>
                  <c:pt idx="5">
                    <c:v>50314.013952377143</c:v>
                  </c:pt>
                  <c:pt idx="6">
                    <c:v>98724.504444326449</c:v>
                  </c:pt>
                  <c:pt idx="7">
                    <c:v>166027.94276198614</c:v>
                  </c:pt>
                  <c:pt idx="8">
                    <c:v>101922.49233826814</c:v>
                  </c:pt>
                  <c:pt idx="9">
                    <c:v>149122.43292006751</c:v>
                  </c:pt>
                </c:numCache>
              </c:numRef>
            </c:minus>
          </c:errBars>
          <c:xVal>
            <c:numRef>
              <c:f>'Cell counts_first time'!$H$2:$Q$2</c:f>
              <c:numCache>
                <c:formatCode>General</c:formatCode>
                <c:ptCount val="10"/>
                <c:pt idx="0">
                  <c:v>0</c:v>
                </c:pt>
                <c:pt idx="1">
                  <c:v>6</c:v>
                </c:pt>
                <c:pt idx="2">
                  <c:v>16</c:v>
                </c:pt>
                <c:pt idx="3">
                  <c:v>23</c:v>
                </c:pt>
                <c:pt idx="4">
                  <c:v>25</c:v>
                </c:pt>
                <c:pt idx="5">
                  <c:v>30</c:v>
                </c:pt>
                <c:pt idx="6">
                  <c:v>40</c:v>
                </c:pt>
                <c:pt idx="7">
                  <c:v>47</c:v>
                </c:pt>
                <c:pt idx="8">
                  <c:v>49</c:v>
                </c:pt>
                <c:pt idx="9">
                  <c:v>54</c:v>
                </c:pt>
              </c:numCache>
            </c:numRef>
          </c:xVal>
          <c:yVal>
            <c:numRef>
              <c:f>'Cell counts_first time'!$H$4:$Q$4</c:f>
              <c:numCache>
                <c:formatCode>General</c:formatCode>
                <c:ptCount val="10"/>
                <c:pt idx="0">
                  <c:v>520666.66666666669</c:v>
                </c:pt>
                <c:pt idx="1">
                  <c:v>556166.66666666686</c:v>
                </c:pt>
                <c:pt idx="2">
                  <c:v>595500</c:v>
                </c:pt>
                <c:pt idx="3">
                  <c:v>784444.4444444445</c:v>
                </c:pt>
                <c:pt idx="4">
                  <c:v>958500</c:v>
                </c:pt>
                <c:pt idx="5">
                  <c:v>1072666.6666666672</c:v>
                </c:pt>
                <c:pt idx="6">
                  <c:v>1605555.555555555</c:v>
                </c:pt>
                <c:pt idx="7">
                  <c:v>2039444.4444444445</c:v>
                </c:pt>
                <c:pt idx="8">
                  <c:v>2197222.222222222</c:v>
                </c:pt>
                <c:pt idx="9">
                  <c:v>2641666.666666666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3737880"/>
        <c:axId val="193737096"/>
      </c:scatterChart>
      <c:valAx>
        <c:axId val="19373788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800" b="0">
                    <a:latin typeface="Helvetica" panose="020B0604020202020204" pitchFamily="34" charset="0"/>
                    <a:cs typeface="Helvetica" panose="020B0604020202020204" pitchFamily="34" charset="0"/>
                  </a:defRPr>
                </a:pPr>
                <a:r>
                  <a:rPr lang="en-US" sz="800" b="0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Hours</a:t>
                </a:r>
                <a:endParaRPr lang="en-US" sz="800" b="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51009252909151037"/>
              <c:y val="0.95870000000000022"/>
            </c:manualLayout>
          </c:layout>
          <c:overlay val="0"/>
        </c:title>
        <c:numFmt formatCode="General" sourceLinked="1"/>
        <c:majorTickMark val="cross"/>
        <c:minorTickMark val="out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en-US"/>
          </a:p>
        </c:txPr>
        <c:crossAx val="193737096"/>
        <c:crosses val="autoZero"/>
        <c:crossBetween val="midCat"/>
        <c:majorUnit val="6"/>
        <c:minorUnit val="2"/>
      </c:valAx>
      <c:valAx>
        <c:axId val="193737096"/>
        <c:scaling>
          <c:orientation val="minMax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800">
                    <a:latin typeface="Helvetica" panose="020B0604020202020204" pitchFamily="34" charset="0"/>
                    <a:cs typeface="Helvetica" panose="020B0604020202020204" pitchFamily="34" charset="0"/>
                  </a:defRPr>
                </a:pPr>
                <a:r>
                  <a:rPr lang="en-US" sz="800" b="0" i="0" baseline="0" dirty="0" smtClean="0">
                    <a:effectLst/>
                    <a:latin typeface="Helvetica" panose="020B0604020202020204" pitchFamily="34" charset="0"/>
                    <a:cs typeface="Helvetica" panose="020B0604020202020204" pitchFamily="34" charset="0"/>
                  </a:rPr>
                  <a:t>Cell density (x10</a:t>
                </a:r>
                <a:r>
                  <a:rPr lang="en-US" sz="800" b="0" i="0" baseline="30000" dirty="0" smtClean="0">
                    <a:effectLst/>
                    <a:latin typeface="Helvetica" panose="020B0604020202020204" pitchFamily="34" charset="0"/>
                    <a:cs typeface="Helvetica" panose="020B0604020202020204" pitchFamily="34" charset="0"/>
                  </a:rPr>
                  <a:t>6</a:t>
                </a:r>
                <a:r>
                  <a:rPr lang="en-US" sz="800" b="0" i="0" baseline="0" dirty="0" smtClean="0">
                    <a:effectLst/>
                    <a:latin typeface="Helvetica" panose="020B0604020202020204" pitchFamily="34" charset="0"/>
                    <a:cs typeface="Helvetica" panose="020B0604020202020204" pitchFamily="34" charset="0"/>
                  </a:rPr>
                  <a:t> cells/mL)</a:t>
                </a:r>
                <a:endParaRPr lang="en-US" sz="800" dirty="0">
                  <a:effectLst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9164996526552455E-2"/>
              <c:y val="0.36053412073490826"/>
            </c:manualLayout>
          </c:layout>
          <c:overlay val="0"/>
        </c:title>
        <c:numFmt formatCode="General" sourceLinked="1"/>
        <c:majorTickMark val="cross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en-US"/>
          </a:p>
        </c:txPr>
        <c:crossAx val="193737880"/>
        <c:crosses val="autoZero"/>
        <c:crossBetween val="midCat"/>
        <c:dispUnits>
          <c:builtInUnit val="millions"/>
        </c:dispUnits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9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F0638EF7-21BA-46D6-B331-2665E60F3993}" type="datetimeFigureOut">
              <a:rPr lang="en-US" smtClean="0"/>
              <a:pPr/>
              <a:t>2/15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1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9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8A23745D-2A52-4D76-8184-F020C4DF11F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2635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679825" y="515938"/>
            <a:ext cx="1935163" cy="25812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23745D-2A52-4D76-8184-F020C4DF11F2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7611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1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1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1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078704-86FC-4871-8292-C5A59EA7DC58}" type="datetimeFigureOut">
              <a:rPr lang="en-US" smtClean="0"/>
              <a:pPr/>
              <a:t>2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438400" y="914400"/>
            <a:ext cx="762000" cy="25146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3962400" y="914400"/>
            <a:ext cx="762000" cy="25146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/>
          <p:cNvSpPr txBox="1"/>
          <p:nvPr/>
        </p:nvSpPr>
        <p:spPr>
          <a:xfrm>
            <a:off x="609600" y="3886200"/>
            <a:ext cx="60198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2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. Cell division in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D. viridis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grown under 12:12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light:dark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cycle occurs at night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D. viridis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ultures were grown under 12h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light:dark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cycles (LD; dashed lines) or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continuous light (LL; solid lines) at 25°C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ell counts were measured in three biological replicates with three technical replicates each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t the different time points of the experiment and also 1 hour before and 1 hour after the light was turned on in the chamber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 significance was assessed by unpaired, two-tailed, Student’s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st.</a:t>
            </a:r>
            <a:r>
              <a:rPr lang="en-US" sz="1200" dirty="0"/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values with different letters are significantly different at 54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hr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(p&lt;0.01).</a:t>
            </a:r>
            <a:endParaRPr lang="en-US" sz="1200" dirty="0" smtClean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60505864"/>
              </p:ext>
            </p:extLst>
          </p:nvPr>
        </p:nvGraphicFramePr>
        <p:xfrm>
          <a:off x="1143000" y="76200"/>
          <a:ext cx="4505610" cy="381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1"/>
          <p:cNvSpPr txBox="1"/>
          <p:nvPr/>
        </p:nvSpPr>
        <p:spPr>
          <a:xfrm>
            <a:off x="5164060" y="1143000"/>
            <a:ext cx="331428" cy="145408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800" b="0" dirty="0">
                <a:latin typeface="Helvetica" panose="020B0604020202020204" pitchFamily="34" charset="0"/>
                <a:cs typeface="Helvetica" panose="020B0604020202020204" pitchFamily="34" charset="0"/>
              </a:rPr>
              <a:t>LL 25°C </a:t>
            </a:r>
          </a:p>
        </p:txBody>
      </p:sp>
      <p:sp>
        <p:nvSpPr>
          <p:cNvPr id="7" name="TextBox 1"/>
          <p:cNvSpPr txBox="1"/>
          <p:nvPr/>
        </p:nvSpPr>
        <p:spPr>
          <a:xfrm>
            <a:off x="5154972" y="1828800"/>
            <a:ext cx="331428" cy="145408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800" b="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LD </a:t>
            </a:r>
            <a:r>
              <a:rPr lang="en-US" sz="800" b="0" dirty="0">
                <a:latin typeface="Helvetica" panose="020B0604020202020204" pitchFamily="34" charset="0"/>
                <a:cs typeface="Helvetica" panose="020B0604020202020204" pitchFamily="34" charset="0"/>
              </a:rPr>
              <a:t>25°C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930230" y="1000260"/>
            <a:ext cx="2247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Helvetica" pitchFamily="34" charset="0"/>
              </a:rPr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021050" y="1565182"/>
            <a:ext cx="2247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Helvetica" pitchFamily="34" charset="0"/>
              </a:rPr>
              <a:t>b</a:t>
            </a:r>
            <a:endParaRPr lang="en-US" sz="800" dirty="0">
              <a:latin typeface="Helvetica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37358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432</TotalTime>
  <Words>125</Words>
  <Application>Microsoft Office PowerPoint</Application>
  <PresentationFormat>On-screen Show (4:3)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wsedero</dc:creator>
  <cp:lastModifiedBy>Soundarya Srirangan</cp:lastModifiedBy>
  <cp:revision>481</cp:revision>
  <cp:lastPrinted>2014-10-28T12:32:56Z</cp:lastPrinted>
  <dcterms:created xsi:type="dcterms:W3CDTF">2012-07-19T19:41:05Z</dcterms:created>
  <dcterms:modified xsi:type="dcterms:W3CDTF">2015-02-16T00:50:31Z</dcterms:modified>
</cp:coreProperties>
</file>